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4130" autoAdjust="0"/>
    <p:restoredTop sz="94635"/>
  </p:normalViewPr>
  <p:slideViewPr>
    <p:cSldViewPr snapToGrid="0">
      <p:cViewPr varScale="1">
        <p:scale>
          <a:sx n="93" d="100"/>
          <a:sy n="93" d="100"/>
        </p:scale>
        <p:origin x="240" y="5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D84A9A5-D78A-89BA-30A4-D9C9C3BFB4E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A10E3E24-ADFF-4433-82EF-F8D9A68D22B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8F769E2-1465-A947-0FE2-7587A2D004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911D0-E2B3-41B8-9E08-AAACECEA6894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91AD7E3-2536-DDE4-CF77-5981C5C8AA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3C1A5FC-556A-F9EE-30E2-4E27C465A0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CD5AEF-F111-41D6-8D31-3ACF0DC0FB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1479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6F4DE4E-E28F-503A-4131-6DCFDE5FDE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1B2DABE-5AAA-E296-DCC5-9D58A6D83C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B41D419-EA84-55AA-825D-9C435A7405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911D0-E2B3-41B8-9E08-AAACECEA6894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9B036F2-DF8B-5D11-426F-B95706BF72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0ED60F6-929F-E8D6-B90C-D17A14520B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CD5AEF-F111-41D6-8D31-3ACF0DC0FB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60552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BF407EE-6031-3C4F-852C-0F00F2F088A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8E440AE-9FF8-567E-9B47-599782E06FD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D481BE4-0CDF-E084-C3ED-7790431B70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911D0-E2B3-41B8-9E08-AAACECEA6894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2CF99D6-61D3-DA24-FE49-088C69C334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339DC56-4863-E486-2040-0037DC25AA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CD5AEF-F111-41D6-8D31-3ACF0DC0FB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3267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1B124DD-506B-3A01-3FB0-6E1F756C48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BEED4D7-1D10-AAAD-71C6-F4CC5A7D652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EF32301-F1D6-1F4B-4B67-20DA7A72C4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911D0-E2B3-41B8-9E08-AAACECEA6894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AFAAB4A-009A-0543-E1A9-DEE580C069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24FC949-A324-8906-9154-38F22C9660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CD5AEF-F111-41D6-8D31-3ACF0DC0FB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00813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6071445-9060-A273-FB69-BD3B0904F5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A2ADA53-A17F-6F80-1E5B-CE305E88DD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0D5E825-CAA4-666B-2357-2C31E183B6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911D0-E2B3-41B8-9E08-AAACECEA6894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F94F99D-00FE-5A1C-17E6-4D9C828526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E3D8679-D07C-CD36-B89B-E9168C89B0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CD5AEF-F111-41D6-8D31-3ACF0DC0FB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51506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C2FB288-731F-0928-03F1-B09419771E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9DA79C4-BD65-F56D-513F-CDFB7858531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3FEF964-AD09-E6E6-81A5-8DF4E20E29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64CA8BA-31D9-7E27-4DD1-848866422C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911D0-E2B3-41B8-9E08-AAACECEA6894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C727F0F-7B0F-BC09-BCD2-6F1B4AB3B5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9542482-4857-29DC-91F2-AAF44A90E8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CD5AEF-F111-41D6-8D31-3ACF0DC0FB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3395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E80B681-48B6-16CA-F7A7-476548A194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7B6A677-EC2E-9AC4-59F1-3968155FD6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383395A-90C6-C8CE-94EA-618B2BE7A20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CB18742-D967-08CC-6085-725A74520EE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5C213E63-DA60-DAAF-52CC-DF3E1711446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0B1AFA4F-2A68-02CE-C9EC-3D003888C9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911D0-E2B3-41B8-9E08-AAACECEA6894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ADE16B37-B44C-85DB-6C9E-0D76422E8E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2DD3FDD6-D7A1-4212-913A-CA6419872B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CD5AEF-F111-41D6-8D31-3ACF0DC0FB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07114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19894A3-4949-C28A-B1B5-8A43C8E7AB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39CAB20-F653-B47D-ED90-7B788F4CF8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911D0-E2B3-41B8-9E08-AAACECEA6894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CF80364E-2F1D-25E1-16C1-188001264E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96734B89-D960-D229-C32E-F2B50EEB86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CD5AEF-F111-41D6-8D31-3ACF0DC0FB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77732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4AD901F5-AFEB-BA5F-34CE-0DA2B8D6B2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911D0-E2B3-41B8-9E08-AAACECEA6894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C71D79F-85D7-C4D3-AFB0-568C11E1D3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EE7A668-0478-AC09-5EA2-7E2F818284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CD5AEF-F111-41D6-8D31-3ACF0DC0FB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17546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3A6DF85-4337-F1D5-67DE-B7478F30F6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D3DF8A8-BC04-BFF0-F5B4-41458A8F18E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CACBA04-EE0A-8193-7F20-158FF54A1C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244A8D8-553B-9F12-8730-E38A26E18C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911D0-E2B3-41B8-9E08-AAACECEA6894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5BA9BF7-9559-9D8F-D587-15FBD10B85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06D36D2-FEC7-BED2-D2F3-EA2BB1CDA1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CD5AEF-F111-41D6-8D31-3ACF0DC0FB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57643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0DBAACD-6DDB-5363-6977-26B029B93F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B8ECCD30-C2BD-791F-2BBD-883F94DC6B1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E933ACD-03CB-17C6-C9B6-5256E71ECF3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A4F4A9D-2CD1-F11F-71F6-47E296E56C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911D0-E2B3-41B8-9E08-AAACECEA6894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5737CB1-734D-C74B-9768-C0F8E263DA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24FD827-93F9-D38B-239A-3A75E1E86F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CD5AEF-F111-41D6-8D31-3ACF0DC0FB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19736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8E472CDF-0202-C64F-13E4-3B4BB30540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86E475A-2F2B-487D-0479-86AD840ADB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A0A5E7A-D4B2-A0CD-642A-554DF1A9323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F5911D0-E2B3-41B8-9E08-AAACECEA6894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8233883-F79E-DA8F-FFC2-AEB4A317775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8CDEB3E-BD1A-0056-7504-940101A27CE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8CD5AEF-F111-41D6-8D31-3ACF0DC0FBE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45252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129BA9E-C3E4-52CE-0816-46A6458DD11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Line 5">
            <a:extLst>
              <a:ext uri="{FF2B5EF4-FFF2-40B4-BE49-F238E27FC236}">
                <a16:creationId xmlns:a16="http://schemas.microsoft.com/office/drawing/2014/main" id="{8EE3A931-4FBA-3150-82FE-3783F718EE91}"/>
              </a:ext>
            </a:extLst>
          </p:cNvPr>
          <p:cNvSpPr>
            <a:spLocks noChangeShapeType="1"/>
          </p:cNvSpPr>
          <p:nvPr/>
        </p:nvSpPr>
        <p:spPr bwMode="auto">
          <a:xfrm>
            <a:off x="3405687" y="5445988"/>
            <a:ext cx="4427954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Line 6">
            <a:extLst>
              <a:ext uri="{FF2B5EF4-FFF2-40B4-BE49-F238E27FC236}">
                <a16:creationId xmlns:a16="http://schemas.microsoft.com/office/drawing/2014/main" id="{ABA8A0F3-4C4E-E7EF-968F-57CB585C33D3}"/>
              </a:ext>
            </a:extLst>
          </p:cNvPr>
          <p:cNvSpPr>
            <a:spLocks noChangeShapeType="1"/>
          </p:cNvSpPr>
          <p:nvPr/>
        </p:nvSpPr>
        <p:spPr bwMode="auto">
          <a:xfrm>
            <a:off x="3405687" y="5445988"/>
            <a:ext cx="0" cy="102419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Line 7">
            <a:extLst>
              <a:ext uri="{FF2B5EF4-FFF2-40B4-BE49-F238E27FC236}">
                <a16:creationId xmlns:a16="http://schemas.microsoft.com/office/drawing/2014/main" id="{75F825A9-C5C8-4F62-C7B8-709F5C0B4F5E}"/>
              </a:ext>
            </a:extLst>
          </p:cNvPr>
          <p:cNvSpPr>
            <a:spLocks noChangeShapeType="1"/>
          </p:cNvSpPr>
          <p:nvPr/>
        </p:nvSpPr>
        <p:spPr bwMode="auto">
          <a:xfrm>
            <a:off x="4520293" y="5445988"/>
            <a:ext cx="0" cy="102419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Line 8">
            <a:extLst>
              <a:ext uri="{FF2B5EF4-FFF2-40B4-BE49-F238E27FC236}">
                <a16:creationId xmlns:a16="http://schemas.microsoft.com/office/drawing/2014/main" id="{49710C7E-3131-68C8-4551-A9DDE0EEF717}"/>
              </a:ext>
            </a:extLst>
          </p:cNvPr>
          <p:cNvSpPr>
            <a:spLocks noChangeShapeType="1"/>
          </p:cNvSpPr>
          <p:nvPr/>
        </p:nvSpPr>
        <p:spPr bwMode="auto">
          <a:xfrm>
            <a:off x="5619664" y="5445988"/>
            <a:ext cx="0" cy="102419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Line 9">
            <a:extLst>
              <a:ext uri="{FF2B5EF4-FFF2-40B4-BE49-F238E27FC236}">
                <a16:creationId xmlns:a16="http://schemas.microsoft.com/office/drawing/2014/main" id="{840A803E-04EC-6F01-97B1-718DAE260431}"/>
              </a:ext>
            </a:extLst>
          </p:cNvPr>
          <p:cNvSpPr>
            <a:spLocks noChangeShapeType="1"/>
          </p:cNvSpPr>
          <p:nvPr/>
        </p:nvSpPr>
        <p:spPr bwMode="auto">
          <a:xfrm>
            <a:off x="6734270" y="5445988"/>
            <a:ext cx="0" cy="102419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Line 10">
            <a:extLst>
              <a:ext uri="{FF2B5EF4-FFF2-40B4-BE49-F238E27FC236}">
                <a16:creationId xmlns:a16="http://schemas.microsoft.com/office/drawing/2014/main" id="{46D4D193-9698-557C-42EA-ABE91A41DE67}"/>
              </a:ext>
            </a:extLst>
          </p:cNvPr>
          <p:cNvSpPr>
            <a:spLocks noChangeShapeType="1"/>
          </p:cNvSpPr>
          <p:nvPr/>
        </p:nvSpPr>
        <p:spPr bwMode="auto">
          <a:xfrm>
            <a:off x="7833641" y="5445988"/>
            <a:ext cx="0" cy="102419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Rectangle 11">
            <a:extLst>
              <a:ext uri="{FF2B5EF4-FFF2-40B4-BE49-F238E27FC236}">
                <a16:creationId xmlns:a16="http://schemas.microsoft.com/office/drawing/2014/main" id="{40FE2B35-8F2F-C6FB-4C12-61A0F87729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06668" y="5685741"/>
            <a:ext cx="8976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Rectangle 12">
            <a:extLst>
              <a:ext uri="{FF2B5EF4-FFF2-40B4-BE49-F238E27FC236}">
                <a16:creationId xmlns:a16="http://schemas.microsoft.com/office/drawing/2014/main" id="{4CC6CFB4-FC4D-BBE7-E9AB-C335F15541F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07020" y="5685741"/>
            <a:ext cx="26930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Rectangle 13">
            <a:extLst>
              <a:ext uri="{FF2B5EF4-FFF2-40B4-BE49-F238E27FC236}">
                <a16:creationId xmlns:a16="http://schemas.microsoft.com/office/drawing/2014/main" id="{E96661D1-A833-9E8C-ED85-AC11F01490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06391" y="5685741"/>
            <a:ext cx="26930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Rectangle 14">
            <a:extLst>
              <a:ext uri="{FF2B5EF4-FFF2-40B4-BE49-F238E27FC236}">
                <a16:creationId xmlns:a16="http://schemas.microsoft.com/office/drawing/2014/main" id="{357B821D-3B39-8032-6311-E53D4D936F7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20997" y="5685741"/>
            <a:ext cx="26930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00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Rectangle 15">
            <a:extLst>
              <a:ext uri="{FF2B5EF4-FFF2-40B4-BE49-F238E27FC236}">
                <a16:creationId xmlns:a16="http://schemas.microsoft.com/office/drawing/2014/main" id="{2664EA6E-BA3B-F0EB-B178-AA16BD4BC2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20368" y="5685741"/>
            <a:ext cx="26930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00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Line 16">
            <a:extLst>
              <a:ext uri="{FF2B5EF4-FFF2-40B4-BE49-F238E27FC236}">
                <a16:creationId xmlns:a16="http://schemas.microsoft.com/office/drawing/2014/main" id="{68B4B125-42A4-057F-54DA-A202B985ED4E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205109" y="1156032"/>
            <a:ext cx="0" cy="4117706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Line 17">
            <a:extLst>
              <a:ext uri="{FF2B5EF4-FFF2-40B4-BE49-F238E27FC236}">
                <a16:creationId xmlns:a16="http://schemas.microsoft.com/office/drawing/2014/main" id="{2EA24DF2-0EB2-A680-6085-1E60AF7F0B6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080700" y="5273738"/>
            <a:ext cx="124409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Line 18">
            <a:extLst>
              <a:ext uri="{FF2B5EF4-FFF2-40B4-BE49-F238E27FC236}">
                <a16:creationId xmlns:a16="http://schemas.microsoft.com/office/drawing/2014/main" id="{5265B114-62CC-4206-5D07-BF6786A634B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080700" y="4447403"/>
            <a:ext cx="124409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Line 19">
            <a:extLst>
              <a:ext uri="{FF2B5EF4-FFF2-40B4-BE49-F238E27FC236}">
                <a16:creationId xmlns:a16="http://schemas.microsoft.com/office/drawing/2014/main" id="{A3351C36-B8DF-D494-8390-D114464CDDD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080700" y="3621069"/>
            <a:ext cx="124409" cy="0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Line 20">
            <a:extLst>
              <a:ext uri="{FF2B5EF4-FFF2-40B4-BE49-F238E27FC236}">
                <a16:creationId xmlns:a16="http://schemas.microsoft.com/office/drawing/2014/main" id="{E840AEA7-E252-75D6-1185-C990B7CFB11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080700" y="2797062"/>
            <a:ext cx="124409" cy="0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Line 21">
            <a:extLst>
              <a:ext uri="{FF2B5EF4-FFF2-40B4-BE49-F238E27FC236}">
                <a16:creationId xmlns:a16="http://schemas.microsoft.com/office/drawing/2014/main" id="{2470BA6B-6DE7-000C-70F2-0B691F1B38F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080700" y="1982367"/>
            <a:ext cx="124409" cy="0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Line 22">
            <a:extLst>
              <a:ext uri="{FF2B5EF4-FFF2-40B4-BE49-F238E27FC236}">
                <a16:creationId xmlns:a16="http://schemas.microsoft.com/office/drawing/2014/main" id="{EC0BC4B5-AB01-6D02-9E1D-7C430C119FF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3080700" y="1156032"/>
            <a:ext cx="124409" cy="0"/>
          </a:xfrm>
          <a:prstGeom prst="line">
            <a:avLst/>
          </a:prstGeom>
          <a:noFill/>
          <a:ln w="7938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Rectangle 23">
            <a:extLst>
              <a:ext uri="{FF2B5EF4-FFF2-40B4-BE49-F238E27FC236}">
                <a16:creationId xmlns:a16="http://schemas.microsoft.com/office/drawing/2014/main" id="{8BA6AA2C-C0FA-A847-5106-D1B18DA3AD9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93218" y="5203907"/>
            <a:ext cx="2244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0</a:t>
            </a:r>
            <a:endParaRPr kumimoji="0" lang="ja-JP" altLang="ja-JP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Rectangle 24">
            <a:extLst>
              <a:ext uri="{FF2B5EF4-FFF2-40B4-BE49-F238E27FC236}">
                <a16:creationId xmlns:a16="http://schemas.microsoft.com/office/drawing/2014/main" id="{A3EE6F66-FB85-B4BB-41D4-69109C6AFF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93218" y="4377572"/>
            <a:ext cx="2244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Rectangle 25">
            <a:extLst>
              <a:ext uri="{FF2B5EF4-FFF2-40B4-BE49-F238E27FC236}">
                <a16:creationId xmlns:a16="http://schemas.microsoft.com/office/drawing/2014/main" id="{B9D7176F-F0F9-1906-EB87-9504A7E7E7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93218" y="3553566"/>
            <a:ext cx="2244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Rectangle 26">
            <a:extLst>
              <a:ext uri="{FF2B5EF4-FFF2-40B4-BE49-F238E27FC236}">
                <a16:creationId xmlns:a16="http://schemas.microsoft.com/office/drawing/2014/main" id="{255618AF-0F88-544A-5FD5-FD85BBD78C0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93218" y="2727231"/>
            <a:ext cx="2244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endParaRPr kumimoji="0" lang="ja-JP" altLang="ja-JP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Rectangle 27">
            <a:extLst>
              <a:ext uri="{FF2B5EF4-FFF2-40B4-BE49-F238E27FC236}">
                <a16:creationId xmlns:a16="http://schemas.microsoft.com/office/drawing/2014/main" id="{5863964F-0C6D-708F-92F5-51DD60FF5C7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93218" y="1900897"/>
            <a:ext cx="2244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Rectangle 28">
            <a:extLst>
              <a:ext uri="{FF2B5EF4-FFF2-40B4-BE49-F238E27FC236}">
                <a16:creationId xmlns:a16="http://schemas.microsoft.com/office/drawing/2014/main" id="{DE5156AA-FA44-460A-7AD2-F60ED51200C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93218" y="1076890"/>
            <a:ext cx="22442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  <a:endParaRPr kumimoji="0" lang="ja-JP" altLang="ja-JP" sz="1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Freeform 29">
            <a:extLst>
              <a:ext uri="{FF2B5EF4-FFF2-40B4-BE49-F238E27FC236}">
                <a16:creationId xmlns:a16="http://schemas.microsoft.com/office/drawing/2014/main" id="{8DC2C5F5-3599-0882-C873-001760F9BFA5}"/>
              </a:ext>
            </a:extLst>
          </p:cNvPr>
          <p:cNvSpPr>
            <a:spLocks/>
          </p:cNvSpPr>
          <p:nvPr/>
        </p:nvSpPr>
        <p:spPr bwMode="auto">
          <a:xfrm>
            <a:off x="3205109" y="983782"/>
            <a:ext cx="5692358" cy="4462206"/>
          </a:xfrm>
          <a:custGeom>
            <a:avLst/>
            <a:gdLst>
              <a:gd name="T0" fmla="*/ 0 w 455"/>
              <a:gd name="T1" fmla="*/ 0 h 389"/>
              <a:gd name="T2" fmla="*/ 0 w 455"/>
              <a:gd name="T3" fmla="*/ 389 h 389"/>
              <a:gd name="T4" fmla="*/ 455 w 455"/>
              <a:gd name="T5" fmla="*/ 389 h 38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55" h="389">
                <a:moveTo>
                  <a:pt x="0" y="0"/>
                </a:moveTo>
                <a:lnTo>
                  <a:pt x="0" y="389"/>
                </a:lnTo>
                <a:lnTo>
                  <a:pt x="455" y="389"/>
                </a:lnTo>
              </a:path>
            </a:pathLst>
          </a:custGeom>
          <a:noFill/>
          <a:ln w="222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5" name="Rectangle 30">
            <a:extLst>
              <a:ext uri="{FF2B5EF4-FFF2-40B4-BE49-F238E27FC236}">
                <a16:creationId xmlns:a16="http://schemas.microsoft.com/office/drawing/2014/main" id="{EB8EEF0B-C7F4-19CF-D619-0B2AC28CCCC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51451" y="6018603"/>
            <a:ext cx="4161363" cy="276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ays since initiation of  </a:t>
            </a:r>
            <a:r>
              <a:rPr kumimoji="0" lang="en-US" altLang="ja-JP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GnP</a:t>
            </a:r>
            <a:r>
              <a:rPr kumimoji="0" lang="en-US" altLang="ja-JP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therapy</a:t>
            </a:r>
            <a:endParaRPr kumimoji="0" lang="ja-JP" altLang="ja-JP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Rectangle 31">
            <a:extLst>
              <a:ext uri="{FF2B5EF4-FFF2-40B4-BE49-F238E27FC236}">
                <a16:creationId xmlns:a16="http://schemas.microsoft.com/office/drawing/2014/main" id="{1DF73569-6BA0-80A8-9C80-6DE810AF76BF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1089681" y="2978431"/>
            <a:ext cx="2255544" cy="2767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en-US" altLang="ja-JP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IPN-free</a:t>
            </a:r>
            <a:r>
              <a:rPr kumimoji="0" lang="ja-JP" altLang="en-US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ja-JP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robability</a:t>
            </a:r>
            <a:endParaRPr kumimoji="0" lang="ja-JP" altLang="ja-JP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Freeform 32">
            <a:extLst>
              <a:ext uri="{FF2B5EF4-FFF2-40B4-BE49-F238E27FC236}">
                <a16:creationId xmlns:a16="http://schemas.microsoft.com/office/drawing/2014/main" id="{A4AEA94C-A906-04FC-8FCA-E324B8B5A5A5}"/>
              </a:ext>
            </a:extLst>
          </p:cNvPr>
          <p:cNvSpPr>
            <a:spLocks/>
          </p:cNvSpPr>
          <p:nvPr/>
        </p:nvSpPr>
        <p:spPr bwMode="auto">
          <a:xfrm>
            <a:off x="3405687" y="1156032"/>
            <a:ext cx="5278507" cy="1983202"/>
          </a:xfrm>
          <a:custGeom>
            <a:avLst/>
            <a:gdLst>
              <a:gd name="T0" fmla="*/ 0 w 422"/>
              <a:gd name="T1" fmla="*/ 0 h 173"/>
              <a:gd name="T2" fmla="*/ 51 w 422"/>
              <a:gd name="T3" fmla="*/ 0 h 173"/>
              <a:gd name="T4" fmla="*/ 51 w 422"/>
              <a:gd name="T5" fmla="*/ 19 h 173"/>
              <a:gd name="T6" fmla="*/ 71 w 422"/>
              <a:gd name="T7" fmla="*/ 19 h 173"/>
              <a:gd name="T8" fmla="*/ 71 w 422"/>
              <a:gd name="T9" fmla="*/ 30 h 173"/>
              <a:gd name="T10" fmla="*/ 75 w 422"/>
              <a:gd name="T11" fmla="*/ 30 h 173"/>
              <a:gd name="T12" fmla="*/ 75 w 422"/>
              <a:gd name="T13" fmla="*/ 40 h 173"/>
              <a:gd name="T14" fmla="*/ 88 w 422"/>
              <a:gd name="T15" fmla="*/ 40 h 173"/>
              <a:gd name="T16" fmla="*/ 88 w 422"/>
              <a:gd name="T17" fmla="*/ 51 h 173"/>
              <a:gd name="T18" fmla="*/ 89 w 422"/>
              <a:gd name="T19" fmla="*/ 51 h 173"/>
              <a:gd name="T20" fmla="*/ 89 w 422"/>
              <a:gd name="T21" fmla="*/ 63 h 173"/>
              <a:gd name="T22" fmla="*/ 94 w 422"/>
              <a:gd name="T23" fmla="*/ 63 h 173"/>
              <a:gd name="T24" fmla="*/ 94 w 422"/>
              <a:gd name="T25" fmla="*/ 74 h 173"/>
              <a:gd name="T26" fmla="*/ 125 w 422"/>
              <a:gd name="T27" fmla="*/ 74 h 173"/>
              <a:gd name="T28" fmla="*/ 125 w 422"/>
              <a:gd name="T29" fmla="*/ 88 h 173"/>
              <a:gd name="T30" fmla="*/ 141 w 422"/>
              <a:gd name="T31" fmla="*/ 88 h 173"/>
              <a:gd name="T32" fmla="*/ 141 w 422"/>
              <a:gd name="T33" fmla="*/ 107 h 173"/>
              <a:gd name="T34" fmla="*/ 156 w 422"/>
              <a:gd name="T35" fmla="*/ 107 h 173"/>
              <a:gd name="T36" fmla="*/ 156 w 422"/>
              <a:gd name="T37" fmla="*/ 126 h 173"/>
              <a:gd name="T38" fmla="*/ 299 w 422"/>
              <a:gd name="T39" fmla="*/ 126 h 173"/>
              <a:gd name="T40" fmla="*/ 299 w 422"/>
              <a:gd name="T41" fmla="*/ 173 h 173"/>
              <a:gd name="T42" fmla="*/ 422 w 422"/>
              <a:gd name="T43" fmla="*/ 173 h 17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</a:cxnLst>
            <a:rect l="0" t="0" r="r" b="b"/>
            <a:pathLst>
              <a:path w="422" h="173">
                <a:moveTo>
                  <a:pt x="0" y="0"/>
                </a:moveTo>
                <a:lnTo>
                  <a:pt x="51" y="0"/>
                </a:lnTo>
                <a:lnTo>
                  <a:pt x="51" y="19"/>
                </a:lnTo>
                <a:lnTo>
                  <a:pt x="71" y="19"/>
                </a:lnTo>
                <a:lnTo>
                  <a:pt x="71" y="30"/>
                </a:lnTo>
                <a:lnTo>
                  <a:pt x="75" y="30"/>
                </a:lnTo>
                <a:lnTo>
                  <a:pt x="75" y="40"/>
                </a:lnTo>
                <a:lnTo>
                  <a:pt x="88" y="40"/>
                </a:lnTo>
                <a:lnTo>
                  <a:pt x="88" y="51"/>
                </a:lnTo>
                <a:lnTo>
                  <a:pt x="89" y="51"/>
                </a:lnTo>
                <a:lnTo>
                  <a:pt x="89" y="63"/>
                </a:lnTo>
                <a:lnTo>
                  <a:pt x="94" y="63"/>
                </a:lnTo>
                <a:lnTo>
                  <a:pt x="94" y="74"/>
                </a:lnTo>
                <a:lnTo>
                  <a:pt x="125" y="74"/>
                </a:lnTo>
                <a:lnTo>
                  <a:pt x="125" y="88"/>
                </a:lnTo>
                <a:lnTo>
                  <a:pt x="141" y="88"/>
                </a:lnTo>
                <a:lnTo>
                  <a:pt x="141" y="107"/>
                </a:lnTo>
                <a:lnTo>
                  <a:pt x="156" y="107"/>
                </a:lnTo>
                <a:lnTo>
                  <a:pt x="156" y="126"/>
                </a:lnTo>
                <a:lnTo>
                  <a:pt x="299" y="126"/>
                </a:lnTo>
                <a:lnTo>
                  <a:pt x="299" y="173"/>
                </a:lnTo>
                <a:lnTo>
                  <a:pt x="422" y="173"/>
                </a:lnTo>
              </a:path>
            </a:pathLst>
          </a:custGeom>
          <a:noFill/>
          <a:ln w="25400" cap="rnd">
            <a:solidFill>
              <a:schemeClr val="tx1"/>
            </a:solidFill>
            <a:prstDash val="sys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 dirty="0"/>
          </a:p>
        </p:txBody>
      </p:sp>
      <p:sp>
        <p:nvSpPr>
          <p:cNvPr id="38" name="Line 33">
            <a:extLst>
              <a:ext uri="{FF2B5EF4-FFF2-40B4-BE49-F238E27FC236}">
                <a16:creationId xmlns:a16="http://schemas.microsoft.com/office/drawing/2014/main" id="{2A80468C-027F-B90F-3D8C-A407CA1D9F25}"/>
              </a:ext>
            </a:extLst>
          </p:cNvPr>
          <p:cNvSpPr>
            <a:spLocks noChangeShapeType="1"/>
          </p:cNvSpPr>
          <p:nvPr/>
        </p:nvSpPr>
        <p:spPr bwMode="auto">
          <a:xfrm>
            <a:off x="3669739" y="1156032"/>
            <a:ext cx="124409" cy="0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9" name="Line 34">
            <a:extLst>
              <a:ext uri="{FF2B5EF4-FFF2-40B4-BE49-F238E27FC236}">
                <a16:creationId xmlns:a16="http://schemas.microsoft.com/office/drawing/2014/main" id="{224B7C63-B7D4-1D19-2286-2861A5CCA929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730675" y="1100167"/>
            <a:ext cx="0" cy="114057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0" name="Line 35">
            <a:extLst>
              <a:ext uri="{FF2B5EF4-FFF2-40B4-BE49-F238E27FC236}">
                <a16:creationId xmlns:a16="http://schemas.microsoft.com/office/drawing/2014/main" id="{D8CBFB2A-8483-5865-D84E-B97CC4260EC1}"/>
              </a:ext>
            </a:extLst>
          </p:cNvPr>
          <p:cNvSpPr>
            <a:spLocks noChangeShapeType="1"/>
          </p:cNvSpPr>
          <p:nvPr/>
        </p:nvSpPr>
        <p:spPr bwMode="auto">
          <a:xfrm>
            <a:off x="3819538" y="1156032"/>
            <a:ext cx="137104" cy="0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1" name="Line 36">
            <a:extLst>
              <a:ext uri="{FF2B5EF4-FFF2-40B4-BE49-F238E27FC236}">
                <a16:creationId xmlns:a16="http://schemas.microsoft.com/office/drawing/2014/main" id="{D2D5844F-9C34-35EA-4689-1B5B950A2E6D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893168" y="1100167"/>
            <a:ext cx="0" cy="114057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2" name="Line 37">
            <a:extLst>
              <a:ext uri="{FF2B5EF4-FFF2-40B4-BE49-F238E27FC236}">
                <a16:creationId xmlns:a16="http://schemas.microsoft.com/office/drawing/2014/main" id="{3FC28423-98E4-76DD-A050-D8D20B11BC1F}"/>
              </a:ext>
            </a:extLst>
          </p:cNvPr>
          <p:cNvSpPr>
            <a:spLocks noChangeShapeType="1"/>
          </p:cNvSpPr>
          <p:nvPr/>
        </p:nvSpPr>
        <p:spPr bwMode="auto">
          <a:xfrm>
            <a:off x="3880473" y="1156032"/>
            <a:ext cx="126948" cy="0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3" name="Line 38">
            <a:extLst>
              <a:ext uri="{FF2B5EF4-FFF2-40B4-BE49-F238E27FC236}">
                <a16:creationId xmlns:a16="http://schemas.microsoft.com/office/drawing/2014/main" id="{2B13CC1B-D19C-7523-B1AF-F790EBD1649A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943948" y="1100167"/>
            <a:ext cx="0" cy="114057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4" name="Line 39">
            <a:extLst>
              <a:ext uri="{FF2B5EF4-FFF2-40B4-BE49-F238E27FC236}">
                <a16:creationId xmlns:a16="http://schemas.microsoft.com/office/drawing/2014/main" id="{FBC36082-8B5F-3BF9-9261-5E1717633563}"/>
              </a:ext>
            </a:extLst>
          </p:cNvPr>
          <p:cNvSpPr>
            <a:spLocks noChangeShapeType="1"/>
          </p:cNvSpPr>
          <p:nvPr/>
        </p:nvSpPr>
        <p:spPr bwMode="auto">
          <a:xfrm>
            <a:off x="3982032" y="1260779"/>
            <a:ext cx="124409" cy="0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5" name="Line 40">
            <a:extLst>
              <a:ext uri="{FF2B5EF4-FFF2-40B4-BE49-F238E27FC236}">
                <a16:creationId xmlns:a16="http://schemas.microsoft.com/office/drawing/2014/main" id="{5390EA51-E3D5-8FE1-0772-FCCB8CFE3F55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042967" y="1202586"/>
            <a:ext cx="0" cy="114057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6" name="Line 41">
            <a:extLst>
              <a:ext uri="{FF2B5EF4-FFF2-40B4-BE49-F238E27FC236}">
                <a16:creationId xmlns:a16="http://schemas.microsoft.com/office/drawing/2014/main" id="{643A66F5-2FB6-0EB0-0622-0CD15B120260}"/>
              </a:ext>
            </a:extLst>
          </p:cNvPr>
          <p:cNvSpPr>
            <a:spLocks noChangeShapeType="1"/>
          </p:cNvSpPr>
          <p:nvPr/>
        </p:nvSpPr>
        <p:spPr bwMode="auto">
          <a:xfrm>
            <a:off x="4055662" y="1374836"/>
            <a:ext cx="126948" cy="0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7" name="Line 42">
            <a:extLst>
              <a:ext uri="{FF2B5EF4-FFF2-40B4-BE49-F238E27FC236}">
                <a16:creationId xmlns:a16="http://schemas.microsoft.com/office/drawing/2014/main" id="{0123E515-2829-2D21-3A59-516AFD7C2C95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119136" y="1316644"/>
            <a:ext cx="0" cy="114057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8" name="Line 43">
            <a:extLst>
              <a:ext uri="{FF2B5EF4-FFF2-40B4-BE49-F238E27FC236}">
                <a16:creationId xmlns:a16="http://schemas.microsoft.com/office/drawing/2014/main" id="{39F49B31-98F1-32F4-8F4D-3C4AF03CACD8}"/>
              </a:ext>
            </a:extLst>
          </p:cNvPr>
          <p:cNvSpPr>
            <a:spLocks noChangeShapeType="1"/>
          </p:cNvSpPr>
          <p:nvPr/>
        </p:nvSpPr>
        <p:spPr bwMode="auto">
          <a:xfrm>
            <a:off x="4294325" y="1614590"/>
            <a:ext cx="124409" cy="0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49" name="Line 44">
            <a:extLst>
              <a:ext uri="{FF2B5EF4-FFF2-40B4-BE49-F238E27FC236}">
                <a16:creationId xmlns:a16="http://schemas.microsoft.com/office/drawing/2014/main" id="{03298DA0-FF15-6FF4-168E-D42199F7E8F6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357799" y="1558725"/>
            <a:ext cx="0" cy="114057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0" name="Line 45">
            <a:extLst>
              <a:ext uri="{FF2B5EF4-FFF2-40B4-BE49-F238E27FC236}">
                <a16:creationId xmlns:a16="http://schemas.microsoft.com/office/drawing/2014/main" id="{1771E63A-0565-3E40-C284-723B9757517F}"/>
              </a:ext>
            </a:extLst>
          </p:cNvPr>
          <p:cNvSpPr>
            <a:spLocks noChangeShapeType="1"/>
          </p:cNvSpPr>
          <p:nvPr/>
        </p:nvSpPr>
        <p:spPr bwMode="auto">
          <a:xfrm>
            <a:off x="4444124" y="1684421"/>
            <a:ext cx="124409" cy="0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1" name="Line 46">
            <a:extLst>
              <a:ext uri="{FF2B5EF4-FFF2-40B4-BE49-F238E27FC236}">
                <a16:creationId xmlns:a16="http://schemas.microsoft.com/office/drawing/2014/main" id="{6EC83C0F-CCD0-1A6D-345E-C6DF63D8E6D9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507598" y="1626228"/>
            <a:ext cx="0" cy="114057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2" name="Line 47">
            <a:extLst>
              <a:ext uri="{FF2B5EF4-FFF2-40B4-BE49-F238E27FC236}">
                <a16:creationId xmlns:a16="http://schemas.microsoft.com/office/drawing/2014/main" id="{DCA0F0BF-19A1-7B62-9713-32E9818E693B}"/>
              </a:ext>
            </a:extLst>
          </p:cNvPr>
          <p:cNvSpPr>
            <a:spLocks noChangeShapeType="1"/>
          </p:cNvSpPr>
          <p:nvPr/>
        </p:nvSpPr>
        <p:spPr bwMode="auto">
          <a:xfrm>
            <a:off x="4593923" y="2005644"/>
            <a:ext cx="137104" cy="0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3" name="Line 48">
            <a:extLst>
              <a:ext uri="{FF2B5EF4-FFF2-40B4-BE49-F238E27FC236}">
                <a16:creationId xmlns:a16="http://schemas.microsoft.com/office/drawing/2014/main" id="{D3860164-B2C8-62F7-9582-F32B7C9AC136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657397" y="1947451"/>
            <a:ext cx="0" cy="114057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4" name="Line 49">
            <a:extLst>
              <a:ext uri="{FF2B5EF4-FFF2-40B4-BE49-F238E27FC236}">
                <a16:creationId xmlns:a16="http://schemas.microsoft.com/office/drawing/2014/main" id="{C5F018A3-82F7-E94B-9CBD-879BC81BF41F}"/>
              </a:ext>
            </a:extLst>
          </p:cNvPr>
          <p:cNvSpPr>
            <a:spLocks noChangeShapeType="1"/>
          </p:cNvSpPr>
          <p:nvPr/>
        </p:nvSpPr>
        <p:spPr bwMode="auto">
          <a:xfrm>
            <a:off x="4756416" y="2005644"/>
            <a:ext cx="126948" cy="0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5" name="Line 50">
            <a:extLst>
              <a:ext uri="{FF2B5EF4-FFF2-40B4-BE49-F238E27FC236}">
                <a16:creationId xmlns:a16="http://schemas.microsoft.com/office/drawing/2014/main" id="{51C41D26-0C17-A7D1-E54D-35A99F4E923C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819890" y="1947451"/>
            <a:ext cx="0" cy="114057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6" name="Line 51">
            <a:extLst>
              <a:ext uri="{FF2B5EF4-FFF2-40B4-BE49-F238E27FC236}">
                <a16:creationId xmlns:a16="http://schemas.microsoft.com/office/drawing/2014/main" id="{98E52B37-14CB-2B56-1AD4-6908EE83886B}"/>
              </a:ext>
            </a:extLst>
          </p:cNvPr>
          <p:cNvSpPr>
            <a:spLocks noChangeShapeType="1"/>
          </p:cNvSpPr>
          <p:nvPr/>
        </p:nvSpPr>
        <p:spPr bwMode="auto">
          <a:xfrm>
            <a:off x="4832585" y="2005644"/>
            <a:ext cx="124409" cy="0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7" name="Line 52">
            <a:extLst>
              <a:ext uri="{FF2B5EF4-FFF2-40B4-BE49-F238E27FC236}">
                <a16:creationId xmlns:a16="http://schemas.microsoft.com/office/drawing/2014/main" id="{042FE1E0-D840-E022-835C-3F80FAA30FC9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893520" y="1947451"/>
            <a:ext cx="0" cy="114057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8" name="Line 53">
            <a:extLst>
              <a:ext uri="{FF2B5EF4-FFF2-40B4-BE49-F238E27FC236}">
                <a16:creationId xmlns:a16="http://schemas.microsoft.com/office/drawing/2014/main" id="{A5AEA174-6D41-F69D-C25B-70B18887768B}"/>
              </a:ext>
            </a:extLst>
          </p:cNvPr>
          <p:cNvSpPr>
            <a:spLocks noChangeShapeType="1"/>
          </p:cNvSpPr>
          <p:nvPr/>
        </p:nvSpPr>
        <p:spPr bwMode="auto">
          <a:xfrm>
            <a:off x="4982384" y="2166255"/>
            <a:ext cx="124409" cy="0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9" name="Line 54">
            <a:extLst>
              <a:ext uri="{FF2B5EF4-FFF2-40B4-BE49-F238E27FC236}">
                <a16:creationId xmlns:a16="http://schemas.microsoft.com/office/drawing/2014/main" id="{276028F5-CB32-32EC-766E-745B1820C26D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045858" y="2108063"/>
            <a:ext cx="0" cy="114057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0" name="Line 55">
            <a:extLst>
              <a:ext uri="{FF2B5EF4-FFF2-40B4-BE49-F238E27FC236}">
                <a16:creationId xmlns:a16="http://schemas.microsoft.com/office/drawing/2014/main" id="{82B2DC8B-46CA-79A2-9934-CEAEAF8F5B11}"/>
              </a:ext>
            </a:extLst>
          </p:cNvPr>
          <p:cNvSpPr>
            <a:spLocks noChangeShapeType="1"/>
          </p:cNvSpPr>
          <p:nvPr/>
        </p:nvSpPr>
        <p:spPr bwMode="auto">
          <a:xfrm>
            <a:off x="5056014" y="2166255"/>
            <a:ext cx="139643" cy="0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1" name="Line 56">
            <a:extLst>
              <a:ext uri="{FF2B5EF4-FFF2-40B4-BE49-F238E27FC236}">
                <a16:creationId xmlns:a16="http://schemas.microsoft.com/office/drawing/2014/main" id="{63801935-73C1-F015-834C-1D3DC1D140E6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132183" y="2108063"/>
            <a:ext cx="0" cy="114057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2" name="Line 57">
            <a:extLst>
              <a:ext uri="{FF2B5EF4-FFF2-40B4-BE49-F238E27FC236}">
                <a16:creationId xmlns:a16="http://schemas.microsoft.com/office/drawing/2014/main" id="{2FDBE548-70DF-DF20-56B9-D2EA80F2B705}"/>
              </a:ext>
            </a:extLst>
          </p:cNvPr>
          <p:cNvSpPr>
            <a:spLocks noChangeShapeType="1"/>
          </p:cNvSpPr>
          <p:nvPr/>
        </p:nvSpPr>
        <p:spPr bwMode="auto">
          <a:xfrm>
            <a:off x="5370846" y="2601535"/>
            <a:ext cx="124409" cy="0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3" name="Line 58">
            <a:extLst>
              <a:ext uri="{FF2B5EF4-FFF2-40B4-BE49-F238E27FC236}">
                <a16:creationId xmlns:a16="http://schemas.microsoft.com/office/drawing/2014/main" id="{D2BD6A3B-E147-445D-51D0-E58A166A9F03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431781" y="2543343"/>
            <a:ext cx="0" cy="125696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4" name="Line 59">
            <a:extLst>
              <a:ext uri="{FF2B5EF4-FFF2-40B4-BE49-F238E27FC236}">
                <a16:creationId xmlns:a16="http://schemas.microsoft.com/office/drawing/2014/main" id="{D0875F08-AF31-A0EF-F486-29B5348EE9A4}"/>
              </a:ext>
            </a:extLst>
          </p:cNvPr>
          <p:cNvSpPr>
            <a:spLocks noChangeShapeType="1"/>
          </p:cNvSpPr>
          <p:nvPr/>
        </p:nvSpPr>
        <p:spPr bwMode="auto">
          <a:xfrm>
            <a:off x="5756768" y="2601535"/>
            <a:ext cx="126948" cy="0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5" name="Line 60">
            <a:extLst>
              <a:ext uri="{FF2B5EF4-FFF2-40B4-BE49-F238E27FC236}">
                <a16:creationId xmlns:a16="http://schemas.microsoft.com/office/drawing/2014/main" id="{6C29E6A2-8DF3-E7EF-43A2-2AF37435417B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820242" y="2543343"/>
            <a:ext cx="0" cy="125696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6" name="Line 61">
            <a:extLst>
              <a:ext uri="{FF2B5EF4-FFF2-40B4-BE49-F238E27FC236}">
                <a16:creationId xmlns:a16="http://schemas.microsoft.com/office/drawing/2014/main" id="{6B2B62D8-4C26-4435-1A91-3EFA30A48444}"/>
              </a:ext>
            </a:extLst>
          </p:cNvPr>
          <p:cNvSpPr>
            <a:spLocks noChangeShapeType="1"/>
          </p:cNvSpPr>
          <p:nvPr/>
        </p:nvSpPr>
        <p:spPr bwMode="auto">
          <a:xfrm>
            <a:off x="5919262" y="2601535"/>
            <a:ext cx="139643" cy="0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7" name="Line 62">
            <a:extLst>
              <a:ext uri="{FF2B5EF4-FFF2-40B4-BE49-F238E27FC236}">
                <a16:creationId xmlns:a16="http://schemas.microsoft.com/office/drawing/2014/main" id="{A38BF1F0-C074-DD0B-4DA8-FA513356460C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995431" y="2543343"/>
            <a:ext cx="0" cy="125696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8" name="Line 63">
            <a:extLst>
              <a:ext uri="{FF2B5EF4-FFF2-40B4-BE49-F238E27FC236}">
                <a16:creationId xmlns:a16="http://schemas.microsoft.com/office/drawing/2014/main" id="{087624B1-1CC0-8516-0C35-0792038D5BA3}"/>
              </a:ext>
            </a:extLst>
          </p:cNvPr>
          <p:cNvSpPr>
            <a:spLocks noChangeShapeType="1"/>
          </p:cNvSpPr>
          <p:nvPr/>
        </p:nvSpPr>
        <p:spPr bwMode="auto">
          <a:xfrm>
            <a:off x="6221399" y="2601535"/>
            <a:ext cx="137104" cy="0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69" name="Line 64">
            <a:extLst>
              <a:ext uri="{FF2B5EF4-FFF2-40B4-BE49-F238E27FC236}">
                <a16:creationId xmlns:a16="http://schemas.microsoft.com/office/drawing/2014/main" id="{2008E144-C950-4FF0-8BA1-2727CC38DE35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6282334" y="2543343"/>
            <a:ext cx="0" cy="125696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0" name="Line 65">
            <a:extLst>
              <a:ext uri="{FF2B5EF4-FFF2-40B4-BE49-F238E27FC236}">
                <a16:creationId xmlns:a16="http://schemas.microsoft.com/office/drawing/2014/main" id="{7F5F7B59-80B2-81B3-8366-CD8F6E9D6242}"/>
              </a:ext>
            </a:extLst>
          </p:cNvPr>
          <p:cNvSpPr>
            <a:spLocks noChangeShapeType="1"/>
          </p:cNvSpPr>
          <p:nvPr/>
        </p:nvSpPr>
        <p:spPr bwMode="auto">
          <a:xfrm>
            <a:off x="6307724" y="2601535"/>
            <a:ext cx="124409" cy="0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1" name="Line 66">
            <a:extLst>
              <a:ext uri="{FF2B5EF4-FFF2-40B4-BE49-F238E27FC236}">
                <a16:creationId xmlns:a16="http://schemas.microsoft.com/office/drawing/2014/main" id="{3A6D2169-4C26-1B99-8E52-61EDFCC5E07F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6371198" y="2543343"/>
            <a:ext cx="0" cy="125696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2" name="Line 67">
            <a:extLst>
              <a:ext uri="{FF2B5EF4-FFF2-40B4-BE49-F238E27FC236}">
                <a16:creationId xmlns:a16="http://schemas.microsoft.com/office/drawing/2014/main" id="{C9B2DE98-C029-3BAB-7F4C-D86A520FB0B7}"/>
              </a:ext>
            </a:extLst>
          </p:cNvPr>
          <p:cNvSpPr>
            <a:spLocks noChangeShapeType="1"/>
          </p:cNvSpPr>
          <p:nvPr/>
        </p:nvSpPr>
        <p:spPr bwMode="auto">
          <a:xfrm>
            <a:off x="6383892" y="2601535"/>
            <a:ext cx="124409" cy="0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3" name="Line 68">
            <a:extLst>
              <a:ext uri="{FF2B5EF4-FFF2-40B4-BE49-F238E27FC236}">
                <a16:creationId xmlns:a16="http://schemas.microsoft.com/office/drawing/2014/main" id="{919000D9-B997-4DD8-3EF7-F5F999AEB7EE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6444828" y="2543343"/>
            <a:ext cx="0" cy="125696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4" name="Line 69">
            <a:extLst>
              <a:ext uri="{FF2B5EF4-FFF2-40B4-BE49-F238E27FC236}">
                <a16:creationId xmlns:a16="http://schemas.microsoft.com/office/drawing/2014/main" id="{3D8D767B-171F-DB8E-F9A1-2C52D3BD0926}"/>
              </a:ext>
            </a:extLst>
          </p:cNvPr>
          <p:cNvSpPr>
            <a:spLocks noChangeShapeType="1"/>
          </p:cNvSpPr>
          <p:nvPr/>
        </p:nvSpPr>
        <p:spPr bwMode="auto">
          <a:xfrm>
            <a:off x="7234446" y="3139235"/>
            <a:ext cx="124409" cy="0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5" name="Line 70">
            <a:extLst>
              <a:ext uri="{FF2B5EF4-FFF2-40B4-BE49-F238E27FC236}">
                <a16:creationId xmlns:a16="http://schemas.microsoft.com/office/drawing/2014/main" id="{0B540DA4-5A62-EA74-92D2-21ED80063452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7295381" y="3083370"/>
            <a:ext cx="0" cy="114057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6" name="Line 71">
            <a:extLst>
              <a:ext uri="{FF2B5EF4-FFF2-40B4-BE49-F238E27FC236}">
                <a16:creationId xmlns:a16="http://schemas.microsoft.com/office/drawing/2014/main" id="{B856B0B3-9487-FB9E-9B57-83704C93257F}"/>
              </a:ext>
            </a:extLst>
          </p:cNvPr>
          <p:cNvSpPr>
            <a:spLocks noChangeShapeType="1"/>
          </p:cNvSpPr>
          <p:nvPr/>
        </p:nvSpPr>
        <p:spPr bwMode="auto">
          <a:xfrm>
            <a:off x="7384244" y="3139235"/>
            <a:ext cx="124409" cy="0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7" name="Line 72">
            <a:extLst>
              <a:ext uri="{FF2B5EF4-FFF2-40B4-BE49-F238E27FC236}">
                <a16:creationId xmlns:a16="http://schemas.microsoft.com/office/drawing/2014/main" id="{67CAA054-D6AC-2F47-6082-C218D1FF2F1E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7445180" y="3083370"/>
            <a:ext cx="0" cy="114057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8" name="Line 73">
            <a:extLst>
              <a:ext uri="{FF2B5EF4-FFF2-40B4-BE49-F238E27FC236}">
                <a16:creationId xmlns:a16="http://schemas.microsoft.com/office/drawing/2014/main" id="{8AEC5180-77EB-BF5B-75E1-CB836BB733C6}"/>
              </a:ext>
            </a:extLst>
          </p:cNvPr>
          <p:cNvSpPr>
            <a:spLocks noChangeShapeType="1"/>
          </p:cNvSpPr>
          <p:nvPr/>
        </p:nvSpPr>
        <p:spPr bwMode="auto">
          <a:xfrm>
            <a:off x="7970745" y="3139235"/>
            <a:ext cx="126948" cy="0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9" name="Line 74">
            <a:extLst>
              <a:ext uri="{FF2B5EF4-FFF2-40B4-BE49-F238E27FC236}">
                <a16:creationId xmlns:a16="http://schemas.microsoft.com/office/drawing/2014/main" id="{A61E1572-0915-3EBE-1876-B579392D8358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8034219" y="3083370"/>
            <a:ext cx="0" cy="114057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0" name="Line 75">
            <a:extLst>
              <a:ext uri="{FF2B5EF4-FFF2-40B4-BE49-F238E27FC236}">
                <a16:creationId xmlns:a16="http://schemas.microsoft.com/office/drawing/2014/main" id="{ABF05DDD-A96C-44A5-C9F8-ACD22A44F708}"/>
              </a:ext>
            </a:extLst>
          </p:cNvPr>
          <p:cNvSpPr>
            <a:spLocks noChangeShapeType="1"/>
          </p:cNvSpPr>
          <p:nvPr/>
        </p:nvSpPr>
        <p:spPr bwMode="auto">
          <a:xfrm>
            <a:off x="8620720" y="3139235"/>
            <a:ext cx="126948" cy="0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1" name="Line 76">
            <a:extLst>
              <a:ext uri="{FF2B5EF4-FFF2-40B4-BE49-F238E27FC236}">
                <a16:creationId xmlns:a16="http://schemas.microsoft.com/office/drawing/2014/main" id="{B2B6A936-1BF2-6062-05B3-289D88612A19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8684194" y="3083370"/>
            <a:ext cx="0" cy="114057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4" name="Freeform 79">
            <a:extLst>
              <a:ext uri="{FF2B5EF4-FFF2-40B4-BE49-F238E27FC236}">
                <a16:creationId xmlns:a16="http://schemas.microsoft.com/office/drawing/2014/main" id="{184AAD76-D346-B6FD-8F66-A4205B83F4B0}"/>
              </a:ext>
            </a:extLst>
          </p:cNvPr>
          <p:cNvSpPr>
            <a:spLocks/>
          </p:cNvSpPr>
          <p:nvPr/>
        </p:nvSpPr>
        <p:spPr bwMode="auto">
          <a:xfrm>
            <a:off x="3405687" y="1156032"/>
            <a:ext cx="2389166" cy="4117706"/>
          </a:xfrm>
          <a:custGeom>
            <a:avLst/>
            <a:gdLst>
              <a:gd name="T0" fmla="*/ 0 w 191"/>
              <a:gd name="T1" fmla="*/ 0 h 359"/>
              <a:gd name="T2" fmla="*/ 51 w 191"/>
              <a:gd name="T3" fmla="*/ 0 h 359"/>
              <a:gd name="T4" fmla="*/ 51 w 191"/>
              <a:gd name="T5" fmla="*/ 55 h 359"/>
              <a:gd name="T6" fmla="*/ 79 w 191"/>
              <a:gd name="T7" fmla="*/ 55 h 359"/>
              <a:gd name="T8" fmla="*/ 79 w 191"/>
              <a:gd name="T9" fmla="*/ 89 h 359"/>
              <a:gd name="T10" fmla="*/ 94 w 191"/>
              <a:gd name="T11" fmla="*/ 89 h 359"/>
              <a:gd name="T12" fmla="*/ 94 w 191"/>
              <a:gd name="T13" fmla="*/ 166 h 359"/>
              <a:gd name="T14" fmla="*/ 107 w 191"/>
              <a:gd name="T15" fmla="*/ 166 h 359"/>
              <a:gd name="T16" fmla="*/ 107 w 191"/>
              <a:gd name="T17" fmla="*/ 230 h 359"/>
              <a:gd name="T18" fmla="*/ 150 w 191"/>
              <a:gd name="T19" fmla="*/ 230 h 359"/>
              <a:gd name="T20" fmla="*/ 150 w 191"/>
              <a:gd name="T21" fmla="*/ 295 h 359"/>
              <a:gd name="T22" fmla="*/ 191 w 191"/>
              <a:gd name="T23" fmla="*/ 295 h 359"/>
              <a:gd name="T24" fmla="*/ 191 w 191"/>
              <a:gd name="T25" fmla="*/ 359 h 3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</a:cxnLst>
            <a:rect l="0" t="0" r="r" b="b"/>
            <a:pathLst>
              <a:path w="191" h="359">
                <a:moveTo>
                  <a:pt x="0" y="0"/>
                </a:moveTo>
                <a:lnTo>
                  <a:pt x="51" y="0"/>
                </a:lnTo>
                <a:lnTo>
                  <a:pt x="51" y="55"/>
                </a:lnTo>
                <a:lnTo>
                  <a:pt x="79" y="55"/>
                </a:lnTo>
                <a:lnTo>
                  <a:pt x="79" y="89"/>
                </a:lnTo>
                <a:lnTo>
                  <a:pt x="94" y="89"/>
                </a:lnTo>
                <a:lnTo>
                  <a:pt x="94" y="166"/>
                </a:lnTo>
                <a:lnTo>
                  <a:pt x="107" y="166"/>
                </a:lnTo>
                <a:lnTo>
                  <a:pt x="107" y="230"/>
                </a:lnTo>
                <a:lnTo>
                  <a:pt x="150" y="230"/>
                </a:lnTo>
                <a:lnTo>
                  <a:pt x="150" y="295"/>
                </a:lnTo>
                <a:lnTo>
                  <a:pt x="191" y="295"/>
                </a:lnTo>
                <a:lnTo>
                  <a:pt x="191" y="359"/>
                </a:lnTo>
              </a:path>
            </a:pathLst>
          </a:custGeom>
          <a:noFill/>
          <a:ln w="2540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5" name="Line 80">
            <a:extLst>
              <a:ext uri="{FF2B5EF4-FFF2-40B4-BE49-F238E27FC236}">
                <a16:creationId xmlns:a16="http://schemas.microsoft.com/office/drawing/2014/main" id="{E9C421D4-C30E-E0C9-6E3E-6C457CF3AD42}"/>
              </a:ext>
            </a:extLst>
          </p:cNvPr>
          <p:cNvSpPr>
            <a:spLocks noChangeShapeType="1"/>
          </p:cNvSpPr>
          <p:nvPr/>
        </p:nvSpPr>
        <p:spPr bwMode="auto">
          <a:xfrm>
            <a:off x="3819538" y="1156032"/>
            <a:ext cx="137104" cy="0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6" name="Line 81">
            <a:extLst>
              <a:ext uri="{FF2B5EF4-FFF2-40B4-BE49-F238E27FC236}">
                <a16:creationId xmlns:a16="http://schemas.microsoft.com/office/drawing/2014/main" id="{D3363D81-B0DF-D9FB-BD06-86370BE7589B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893168" y="1100167"/>
            <a:ext cx="0" cy="114057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7" name="Line 82">
            <a:extLst>
              <a:ext uri="{FF2B5EF4-FFF2-40B4-BE49-F238E27FC236}">
                <a16:creationId xmlns:a16="http://schemas.microsoft.com/office/drawing/2014/main" id="{A8209E08-57A4-C518-A884-BD40B3BB8379}"/>
              </a:ext>
            </a:extLst>
          </p:cNvPr>
          <p:cNvSpPr>
            <a:spLocks noChangeShapeType="1"/>
          </p:cNvSpPr>
          <p:nvPr/>
        </p:nvSpPr>
        <p:spPr bwMode="auto">
          <a:xfrm>
            <a:off x="4131831" y="1786840"/>
            <a:ext cx="124409" cy="0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8" name="Line 83">
            <a:extLst>
              <a:ext uri="{FF2B5EF4-FFF2-40B4-BE49-F238E27FC236}">
                <a16:creationId xmlns:a16="http://schemas.microsoft.com/office/drawing/2014/main" id="{25F58DB0-7F44-725B-7782-465384935612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195305" y="1728647"/>
            <a:ext cx="0" cy="116385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9" name="Line 84">
            <a:extLst>
              <a:ext uri="{FF2B5EF4-FFF2-40B4-BE49-F238E27FC236}">
                <a16:creationId xmlns:a16="http://schemas.microsoft.com/office/drawing/2014/main" id="{1149023C-BBBC-7C8B-40FB-CA5A14C4957D}"/>
              </a:ext>
            </a:extLst>
          </p:cNvPr>
          <p:cNvSpPr>
            <a:spLocks noChangeShapeType="1"/>
          </p:cNvSpPr>
          <p:nvPr/>
        </p:nvSpPr>
        <p:spPr bwMode="auto">
          <a:xfrm>
            <a:off x="4294325" y="1786840"/>
            <a:ext cx="124409" cy="0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0" name="Line 85">
            <a:extLst>
              <a:ext uri="{FF2B5EF4-FFF2-40B4-BE49-F238E27FC236}">
                <a16:creationId xmlns:a16="http://schemas.microsoft.com/office/drawing/2014/main" id="{2F9C6CFF-3E38-86A7-11A5-3F9FE44FF8B8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357799" y="1728647"/>
            <a:ext cx="0" cy="116385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1" name="Line 86">
            <a:extLst>
              <a:ext uri="{FF2B5EF4-FFF2-40B4-BE49-F238E27FC236}">
                <a16:creationId xmlns:a16="http://schemas.microsoft.com/office/drawing/2014/main" id="{3889B1DE-08A6-FF79-1936-2BC5D9E1B35B}"/>
              </a:ext>
            </a:extLst>
          </p:cNvPr>
          <p:cNvSpPr>
            <a:spLocks noChangeShapeType="1"/>
          </p:cNvSpPr>
          <p:nvPr/>
        </p:nvSpPr>
        <p:spPr bwMode="auto">
          <a:xfrm>
            <a:off x="4370494" y="2177894"/>
            <a:ext cx="124409" cy="0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2" name="Line 87">
            <a:extLst>
              <a:ext uri="{FF2B5EF4-FFF2-40B4-BE49-F238E27FC236}">
                <a16:creationId xmlns:a16="http://schemas.microsoft.com/office/drawing/2014/main" id="{FAC66AC8-5061-8349-04E4-B96E5B376D0B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431429" y="2119701"/>
            <a:ext cx="0" cy="114057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3" name="Line 88">
            <a:extLst>
              <a:ext uri="{FF2B5EF4-FFF2-40B4-BE49-F238E27FC236}">
                <a16:creationId xmlns:a16="http://schemas.microsoft.com/office/drawing/2014/main" id="{1A9544D1-BB97-4E2C-161A-6367FAB01A80}"/>
              </a:ext>
            </a:extLst>
          </p:cNvPr>
          <p:cNvSpPr>
            <a:spLocks noChangeShapeType="1"/>
          </p:cNvSpPr>
          <p:nvPr/>
        </p:nvSpPr>
        <p:spPr bwMode="auto">
          <a:xfrm>
            <a:off x="4593923" y="3060093"/>
            <a:ext cx="137104" cy="0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4" name="Line 89">
            <a:extLst>
              <a:ext uri="{FF2B5EF4-FFF2-40B4-BE49-F238E27FC236}">
                <a16:creationId xmlns:a16="http://schemas.microsoft.com/office/drawing/2014/main" id="{5BE41932-9163-08A3-9B6F-721AD932C8A2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657397" y="3001900"/>
            <a:ext cx="0" cy="116385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5" name="Line 90">
            <a:extLst>
              <a:ext uri="{FF2B5EF4-FFF2-40B4-BE49-F238E27FC236}">
                <a16:creationId xmlns:a16="http://schemas.microsoft.com/office/drawing/2014/main" id="{DC7808C3-5B75-112C-B971-08156F51849A}"/>
              </a:ext>
            </a:extLst>
          </p:cNvPr>
          <p:cNvSpPr>
            <a:spLocks noChangeShapeType="1"/>
          </p:cNvSpPr>
          <p:nvPr/>
        </p:nvSpPr>
        <p:spPr bwMode="auto">
          <a:xfrm>
            <a:off x="4682786" y="3060093"/>
            <a:ext cx="124409" cy="0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96" name="Line 91">
            <a:extLst>
              <a:ext uri="{FF2B5EF4-FFF2-40B4-BE49-F238E27FC236}">
                <a16:creationId xmlns:a16="http://schemas.microsoft.com/office/drawing/2014/main" id="{85494B4C-EC2B-5DDF-E74E-299C5E48E9DE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743721" y="3001900"/>
            <a:ext cx="0" cy="116385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00" name="Rectangle 95">
            <a:extLst>
              <a:ext uri="{FF2B5EF4-FFF2-40B4-BE49-F238E27FC236}">
                <a16:creationId xmlns:a16="http://schemas.microsoft.com/office/drawing/2014/main" id="{9614AB08-713F-A407-AE9A-9349F125BA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65416" y="6362200"/>
            <a:ext cx="0" cy="276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3" name="Rectangle 98">
            <a:extLst>
              <a:ext uri="{FF2B5EF4-FFF2-40B4-BE49-F238E27FC236}">
                <a16:creationId xmlns:a16="http://schemas.microsoft.com/office/drawing/2014/main" id="{C253A3AA-0C14-9C96-137F-5F4AA96488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34622" y="6362200"/>
            <a:ext cx="0" cy="276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5" name="Rectangle 100">
            <a:extLst>
              <a:ext uri="{FF2B5EF4-FFF2-40B4-BE49-F238E27FC236}">
                <a16:creationId xmlns:a16="http://schemas.microsoft.com/office/drawing/2014/main" id="{8286F10A-3E51-5341-7A2F-C8D920449DA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21273" y="6581004"/>
            <a:ext cx="0" cy="276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7" name="Rectangle 102">
            <a:extLst>
              <a:ext uri="{FF2B5EF4-FFF2-40B4-BE49-F238E27FC236}">
                <a16:creationId xmlns:a16="http://schemas.microsoft.com/office/drawing/2014/main" id="{5AA46316-49C1-B85F-146D-642F831BEA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35250" y="6581004"/>
            <a:ext cx="0" cy="276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9" name="Rectangle 104">
            <a:extLst>
              <a:ext uri="{FF2B5EF4-FFF2-40B4-BE49-F238E27FC236}">
                <a16:creationId xmlns:a16="http://schemas.microsoft.com/office/drawing/2014/main" id="{D94C91F9-CC1E-CE0C-159D-8FF7918BA452}"/>
              </a:ext>
            </a:extLst>
          </p:cNvPr>
          <p:cNvSpPr>
            <a:spLocks noChangeArrowheads="1"/>
          </p:cNvSpPr>
          <p:nvPr/>
        </p:nvSpPr>
        <p:spPr bwMode="auto">
          <a:xfrm>
            <a:off x="9145016" y="1912185"/>
            <a:ext cx="1967697" cy="2164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og-rank p = 0.004</a:t>
            </a:r>
            <a:endParaRPr kumimoji="0" lang="ja-JP" altLang="ja-JP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Line 107">
            <a:extLst>
              <a:ext uri="{FF2B5EF4-FFF2-40B4-BE49-F238E27FC236}">
                <a16:creationId xmlns:a16="http://schemas.microsoft.com/office/drawing/2014/main" id="{ACA81878-342B-DC19-771C-F6713FF26669}"/>
              </a:ext>
            </a:extLst>
          </p:cNvPr>
          <p:cNvSpPr>
            <a:spLocks noChangeShapeType="1"/>
          </p:cNvSpPr>
          <p:nvPr/>
        </p:nvSpPr>
        <p:spPr bwMode="auto">
          <a:xfrm>
            <a:off x="7295381" y="1373672"/>
            <a:ext cx="363072" cy="0"/>
          </a:xfrm>
          <a:prstGeom prst="line">
            <a:avLst/>
          </a:prstGeom>
          <a:noFill/>
          <a:ln w="25400" cap="rnd">
            <a:solidFill>
              <a:srgbClr val="000000"/>
            </a:solidFill>
            <a:prstDash val="sysDot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3" name="Line 108">
            <a:extLst>
              <a:ext uri="{FF2B5EF4-FFF2-40B4-BE49-F238E27FC236}">
                <a16:creationId xmlns:a16="http://schemas.microsoft.com/office/drawing/2014/main" id="{F3F7BBDE-5CA4-3BB5-181B-01BE6765F56B}"/>
              </a:ext>
            </a:extLst>
          </p:cNvPr>
          <p:cNvSpPr>
            <a:spLocks noChangeShapeType="1"/>
          </p:cNvSpPr>
          <p:nvPr/>
        </p:nvSpPr>
        <p:spPr bwMode="auto">
          <a:xfrm>
            <a:off x="7295381" y="1127402"/>
            <a:ext cx="363072" cy="0"/>
          </a:xfrm>
          <a:prstGeom prst="line">
            <a:avLst/>
          </a:prstGeom>
          <a:noFill/>
          <a:ln w="25400" cap="rnd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115" name="Rectangle 110">
            <a:extLst>
              <a:ext uri="{FF2B5EF4-FFF2-40B4-BE49-F238E27FC236}">
                <a16:creationId xmlns:a16="http://schemas.microsoft.com/office/drawing/2014/main" id="{67F31CD8-7647-4EBB-7D06-0330497A05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66647" y="946539"/>
            <a:ext cx="309229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iabetes mellitus</a:t>
            </a:r>
            <a:r>
              <a:rPr kumimoji="0" lang="ja-JP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r>
              <a:rPr kumimoji="0" lang="en-US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 (n=14)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" name="Rectangle 111">
            <a:extLst>
              <a:ext uri="{FF2B5EF4-FFF2-40B4-BE49-F238E27FC236}">
                <a16:creationId xmlns:a16="http://schemas.microsoft.com/office/drawing/2014/main" id="{1EBED69C-9237-7593-FE3A-CDF0E602718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66647" y="1216552"/>
            <a:ext cx="309229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o</a:t>
            </a:r>
            <a:r>
              <a:rPr kumimoji="0" lang="ja-JP" altLang="en-US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ja-JP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iabetes mellitus (n=43)</a:t>
            </a:r>
            <a:endParaRPr kumimoji="0" lang="ja-JP" altLang="ja-JP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Rectangle 30">
            <a:extLst>
              <a:ext uri="{FF2B5EF4-FFF2-40B4-BE49-F238E27FC236}">
                <a16:creationId xmlns:a16="http://schemas.microsoft.com/office/drawing/2014/main" id="{4D2732F3-44DF-8774-1771-6375F3DA8F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5524" y="179444"/>
            <a:ext cx="1054867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en-US" altLang="ja-JP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 S1. Kaplan–Meier curves for time to grade ≥2 CIPN stratified by the history of diabetes mellitus.</a:t>
            </a:r>
          </a:p>
        </p:txBody>
      </p:sp>
    </p:spTree>
    <p:extLst>
      <p:ext uri="{BB962C8B-B14F-4D97-AF65-F5344CB8AC3E}">
        <p14:creationId xmlns:p14="http://schemas.microsoft.com/office/powerpoint/2010/main" val="6823228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</TotalTime>
  <Words>60</Words>
  <Application>Microsoft Macintosh PowerPoint</Application>
  <PresentationFormat>ワイド画面</PresentationFormat>
  <Paragraphs>1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具也 伴</dc:creator>
  <cp:lastModifiedBy>伴 具也 (洛和会音羽病院 薬剤部)</cp:lastModifiedBy>
  <cp:revision>10</cp:revision>
  <dcterms:created xsi:type="dcterms:W3CDTF">2026-02-22T15:22:00Z</dcterms:created>
  <dcterms:modified xsi:type="dcterms:W3CDTF">2026-03-12T13:16:24Z</dcterms:modified>
</cp:coreProperties>
</file>